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8" r:id="rId2"/>
  </p:sldIdLst>
  <p:sldSz cx="9144000" cy="6858000" type="screen4x3"/>
  <p:notesSz cx="6888163" cy="100187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46" userDrawn="1">
          <p15:clr>
            <a:srgbClr val="A4A3A4"/>
          </p15:clr>
        </p15:guide>
        <p15:guide id="2" pos="158" userDrawn="1">
          <p15:clr>
            <a:srgbClr val="A4A3A4"/>
          </p15:clr>
        </p15:guide>
        <p15:guide id="3" orient="horz" pos="3974" userDrawn="1">
          <p15:clr>
            <a:srgbClr val="A4A3A4"/>
          </p15:clr>
        </p15:guide>
        <p15:guide id="8" pos="5602" userDrawn="1">
          <p15:clr>
            <a:srgbClr val="A4A3A4"/>
          </p15:clr>
        </p15:guide>
        <p15:guide id="9" pos="2699" userDrawn="1">
          <p15:clr>
            <a:srgbClr val="A4A3A4"/>
          </p15:clr>
        </p15:guide>
        <p15:guide id="10" pos="519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597" autoAdjust="0"/>
    <p:restoredTop sz="92652" autoAdjust="0"/>
  </p:normalViewPr>
  <p:slideViewPr>
    <p:cSldViewPr snapToGrid="0" showGuides="1">
      <p:cViewPr varScale="1">
        <p:scale>
          <a:sx n="58" d="100"/>
          <a:sy n="58" d="100"/>
        </p:scale>
        <p:origin x="984" y="282"/>
      </p:cViewPr>
      <p:guideLst>
        <p:guide orient="horz" pos="346"/>
        <p:guide pos="158"/>
        <p:guide orient="horz" pos="3974"/>
        <p:guide pos="5602"/>
        <p:guide pos="2699"/>
        <p:guide pos="5193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瑞貴 久野" userId="cfc45a03820de899" providerId="LiveId" clId="{6431B9FB-8F42-4758-A687-D722AB889154}"/>
    <pc:docChg chg="delSld">
      <pc:chgData name="瑞貴 久野" userId="cfc45a03820de899" providerId="LiveId" clId="{6431B9FB-8F42-4758-A687-D722AB889154}" dt="2025-12-03T11:56:39.558" v="3" actId="47"/>
      <pc:docMkLst>
        <pc:docMk/>
      </pc:docMkLst>
      <pc:sldChg chg="del">
        <pc:chgData name="瑞貴 久野" userId="cfc45a03820de899" providerId="LiveId" clId="{6431B9FB-8F42-4758-A687-D722AB889154}" dt="2025-12-03T11:56:38.125" v="1" actId="47"/>
        <pc:sldMkLst>
          <pc:docMk/>
          <pc:sldMk cId="3642152188" sldId="275"/>
        </pc:sldMkLst>
      </pc:sldChg>
      <pc:sldChg chg="del">
        <pc:chgData name="瑞貴 久野" userId="cfc45a03820de899" providerId="LiveId" clId="{6431B9FB-8F42-4758-A687-D722AB889154}" dt="2025-12-03T11:56:37.621" v="0" actId="47"/>
        <pc:sldMkLst>
          <pc:docMk/>
          <pc:sldMk cId="3674391654" sldId="276"/>
        </pc:sldMkLst>
      </pc:sldChg>
      <pc:sldChg chg="del">
        <pc:chgData name="瑞貴 久野" userId="cfc45a03820de899" providerId="LiveId" clId="{6431B9FB-8F42-4758-A687-D722AB889154}" dt="2025-12-03T11:56:38.617" v="2" actId="47"/>
        <pc:sldMkLst>
          <pc:docMk/>
          <pc:sldMk cId="243260980" sldId="277"/>
        </pc:sldMkLst>
      </pc:sldChg>
      <pc:sldChg chg="del">
        <pc:chgData name="瑞貴 久野" userId="cfc45a03820de899" providerId="LiveId" clId="{6431B9FB-8F42-4758-A687-D722AB889154}" dt="2025-12-03T11:56:39.558" v="3" actId="47"/>
        <pc:sldMkLst>
          <pc:docMk/>
          <pc:sldMk cId="2557645125" sldId="279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4871" cy="502676"/>
          </a:xfrm>
          <a:prstGeom prst="rect">
            <a:avLst/>
          </a:prstGeom>
        </p:spPr>
        <p:txBody>
          <a:bodyPr vert="horz" lIns="96606" tIns="48303" rIns="96606" bIns="48303" rtlCol="0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901698" y="0"/>
            <a:ext cx="2984871" cy="502676"/>
          </a:xfrm>
          <a:prstGeom prst="rect">
            <a:avLst/>
          </a:prstGeom>
        </p:spPr>
        <p:txBody>
          <a:bodyPr vert="horz" lIns="96606" tIns="48303" rIns="96606" bIns="48303" rtlCol="0"/>
          <a:lstStyle>
            <a:lvl1pPr algn="r">
              <a:defRPr sz="1300"/>
            </a:lvl1pPr>
          </a:lstStyle>
          <a:p>
            <a:fld id="{BADC6A84-B46E-49FA-AD5B-21FCDB6E3018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90625" y="1252538"/>
            <a:ext cx="4506913" cy="33813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06" tIns="48303" rIns="96606" bIns="48303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8817" y="4821506"/>
            <a:ext cx="5510530" cy="3944868"/>
          </a:xfrm>
          <a:prstGeom prst="rect">
            <a:avLst/>
          </a:prstGeom>
        </p:spPr>
        <p:txBody>
          <a:bodyPr vert="horz" lIns="96606" tIns="48303" rIns="96606" bIns="48303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516039"/>
            <a:ext cx="2984871" cy="502674"/>
          </a:xfrm>
          <a:prstGeom prst="rect">
            <a:avLst/>
          </a:prstGeom>
        </p:spPr>
        <p:txBody>
          <a:bodyPr vert="horz" lIns="96606" tIns="48303" rIns="96606" bIns="48303" rtlCol="0" anchor="b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901698" y="9516039"/>
            <a:ext cx="2984871" cy="502674"/>
          </a:xfrm>
          <a:prstGeom prst="rect">
            <a:avLst/>
          </a:prstGeom>
        </p:spPr>
        <p:txBody>
          <a:bodyPr vert="horz" lIns="96606" tIns="48303" rIns="96606" bIns="48303" rtlCol="0" anchor="b"/>
          <a:lstStyle>
            <a:lvl1pPr algn="r">
              <a:defRPr sz="1300"/>
            </a:lvl1pPr>
          </a:lstStyle>
          <a:p>
            <a:fld id="{B2D2A62E-0375-4C2B-A19B-15F74851CA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73618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BEE49E2-F74B-DCDC-AFAF-DE57C88221B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0DB9EC02-E21C-8484-A998-66DD52AB0F54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1189038" y="1252538"/>
            <a:ext cx="4510087" cy="3381375"/>
          </a:xfrm>
        </p:spPr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7039CC04-A0BE-1489-4694-3337C71D6164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SUPP Table S1</a:t>
            </a:r>
            <a:endParaRPr kumimoji="1" lang="ja-JP" altLang="en-US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51573CB2-9E03-F512-9C82-33B055FAE73E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2D2A62E-0375-4C2B-A19B-15F74851CA58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78759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78176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76244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14288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98391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41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6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64873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09990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8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17442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49172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65170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8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07996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8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91282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8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3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3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3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73568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68F4305-5788-0400-7141-79C4F590A45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BC7B9804-A501-FBBC-525D-D87445A08F1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57588229"/>
              </p:ext>
            </p:extLst>
          </p:nvPr>
        </p:nvGraphicFramePr>
        <p:xfrm>
          <a:off x="280956" y="889537"/>
          <a:ext cx="8405093" cy="5803366"/>
        </p:xfrm>
        <a:graphic>
          <a:graphicData uri="http://schemas.openxmlformats.org/drawingml/2006/table">
            <a:tbl>
              <a:tblPr/>
              <a:tblGrid>
                <a:gridCol w="3468699">
                  <a:extLst>
                    <a:ext uri="{9D8B030D-6E8A-4147-A177-3AD203B41FA5}">
                      <a16:colId xmlns:a16="http://schemas.microsoft.com/office/drawing/2014/main" val="131430130"/>
                    </a:ext>
                  </a:extLst>
                </a:gridCol>
                <a:gridCol w="791330">
                  <a:extLst>
                    <a:ext uri="{9D8B030D-6E8A-4147-A177-3AD203B41FA5}">
                      <a16:colId xmlns:a16="http://schemas.microsoft.com/office/drawing/2014/main" val="3504298338"/>
                    </a:ext>
                  </a:extLst>
                </a:gridCol>
                <a:gridCol w="1355928">
                  <a:extLst>
                    <a:ext uri="{9D8B030D-6E8A-4147-A177-3AD203B41FA5}">
                      <a16:colId xmlns:a16="http://schemas.microsoft.com/office/drawing/2014/main" val="3269429012"/>
                    </a:ext>
                  </a:extLst>
                </a:gridCol>
                <a:gridCol w="843064">
                  <a:extLst>
                    <a:ext uri="{9D8B030D-6E8A-4147-A177-3AD203B41FA5}">
                      <a16:colId xmlns:a16="http://schemas.microsoft.com/office/drawing/2014/main" val="293225431"/>
                    </a:ext>
                  </a:extLst>
                </a:gridCol>
                <a:gridCol w="1199888">
                  <a:extLst>
                    <a:ext uri="{9D8B030D-6E8A-4147-A177-3AD203B41FA5}">
                      <a16:colId xmlns:a16="http://schemas.microsoft.com/office/drawing/2014/main" val="1643776640"/>
                    </a:ext>
                  </a:extLst>
                </a:gridCol>
                <a:gridCol w="746184">
                  <a:extLst>
                    <a:ext uri="{9D8B030D-6E8A-4147-A177-3AD203B41FA5}">
                      <a16:colId xmlns:a16="http://schemas.microsoft.com/office/drawing/2014/main" val="2068121892"/>
                    </a:ext>
                  </a:extLst>
                </a:gridCol>
              </a:tblGrid>
              <a:tr h="366668">
                <a:tc rowSpan="3">
                  <a:txBody>
                    <a:bodyPr/>
                    <a:lstStyle/>
                    <a:p>
                      <a:pPr algn="l" fontAlgn="ctr"/>
                      <a:r>
                        <a:rPr lang="ja-JP" alt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Low (IS&lt;3.7)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High (IS</a:t>
                      </a:r>
                      <a:r>
                        <a:rPr lang="ja-JP" alt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≧</a:t>
                      </a: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.7)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</a:t>
                      </a:r>
                      <a:r>
                        <a:rPr lang="en-US" sz="14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-value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55550101"/>
                  </a:ext>
                </a:extLst>
              </a:tr>
              <a:tr h="36666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n=321)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n=353)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88736691"/>
                  </a:ext>
                </a:extLst>
              </a:tr>
              <a:tr h="381947">
                <a:tc vMerge="1">
                  <a:txBody>
                    <a:bodyPr/>
                    <a:lstStyle/>
                    <a:p>
                      <a:pPr algn="ctr" fontAlgn="ctr"/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Median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Quartile</a:t>
                      </a:r>
                      <a:r>
                        <a:rPr lang="ja-JP" alt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 </a:t>
                      </a: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range</a:t>
                      </a:r>
                      <a:r>
                        <a:rPr lang="ja-JP" alt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　　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Median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Quartile range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altLang="ja-JP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61770048"/>
                  </a:ext>
                </a:extLst>
              </a:tr>
              <a:tr h="3819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ge </a:t>
                      </a:r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year)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7.0</a:t>
                      </a:r>
                      <a:endParaRPr lang="en-US" altLang="ja-JP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61.0 - 70.0)</a:t>
                      </a:r>
                      <a:endParaRPr kumimoji="1" lang="ja-JP" altLang="en-US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8.0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64.0 - 72.0)</a:t>
                      </a:r>
                      <a:endParaRPr kumimoji="1" lang="ja-JP" altLang="en-US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02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91360138"/>
                  </a:ext>
                </a:extLst>
              </a:tr>
              <a:tr h="3819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r (mg/dl)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67</a:t>
                      </a:r>
                      <a:endParaRPr lang="en-US" altLang="ja-JP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0.61 - 0.81)</a:t>
                      </a:r>
                      <a:endParaRPr kumimoji="1" lang="ja-JP" altLang="en-US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71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0.62 - 0.81)</a:t>
                      </a:r>
                      <a:endParaRPr kumimoji="1" lang="ja-JP" altLang="en-US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04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29328368"/>
                  </a:ext>
                </a:extLst>
              </a:tr>
              <a:tr h="3819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eGFR (ml/min/1.73m</a:t>
                      </a:r>
                      <a:r>
                        <a:rPr lang="en-US" sz="14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</a:t>
                      </a:r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)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73.3</a:t>
                      </a:r>
                      <a:endParaRPr lang="en-US" altLang="ja-JP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67.9 - 81.5)</a:t>
                      </a:r>
                      <a:endParaRPr kumimoji="1" lang="ja-JP" altLang="en-US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72.2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66.8 – 78.6)</a:t>
                      </a:r>
                      <a:endParaRPr kumimoji="1" lang="ja-JP" altLang="en-US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01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32437392"/>
                  </a:ext>
                </a:extLst>
              </a:tr>
              <a:tr h="3819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BMI (kg/m</a:t>
                      </a:r>
                      <a:r>
                        <a:rPr lang="en-US" sz="14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</a:t>
                      </a: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)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9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20.8 - 25.3)</a:t>
                      </a:r>
                      <a:endParaRPr kumimoji="1" lang="ja-JP" altLang="en-US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7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20.7 - 25.2)</a:t>
                      </a:r>
                      <a:endParaRPr kumimoji="1" lang="ja-JP" altLang="en-US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42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13868962"/>
                  </a:ext>
                </a:extLst>
              </a:tr>
              <a:tr h="3819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Estimated volume of salt intake (g/day)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9.3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7.9 – 10.9)</a:t>
                      </a:r>
                      <a:endParaRPr kumimoji="1" lang="ja-JP" altLang="en-US" sz="1400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9.3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7.9 – 11.0)</a:t>
                      </a:r>
                      <a:endParaRPr kumimoji="1" lang="ja-JP" altLang="en-US" sz="1400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84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04967357"/>
                  </a:ext>
                </a:extLst>
              </a:tr>
              <a:tr h="3819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Urinary albumin creatinine ratio (mg/</a:t>
                      </a:r>
                      <a:r>
                        <a:rPr lang="en-US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gCr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) 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5.9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9.2 - 41.0)</a:t>
                      </a:r>
                      <a:endParaRPr kumimoji="1" lang="ja-JP" altLang="en-US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9.1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5.6 - 15.9)</a:t>
                      </a:r>
                      <a:endParaRPr kumimoji="1" lang="ja-JP" altLang="en-US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47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08089698"/>
                  </a:ext>
                </a:extLst>
              </a:tr>
              <a:tr h="410640"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ase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/>
                        <a:t>%</a:t>
                      </a:r>
                      <a:endParaRPr kumimoji="1" lang="ja-JP" altLang="en-US" sz="1400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ase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/>
                        <a:t>%</a:t>
                      </a:r>
                      <a:endParaRPr kumimoji="1" lang="ja-JP" altLang="en-US" sz="1400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43655654"/>
                  </a:ext>
                </a:extLst>
              </a:tr>
              <a:tr h="4106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Male, sex n (%)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45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45.2)</a:t>
                      </a:r>
                      <a:endParaRPr kumimoji="1" lang="ja-JP" altLang="en-US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73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49.0)</a:t>
                      </a:r>
                      <a:endParaRPr kumimoji="1" lang="ja-JP" altLang="en-US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35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54037492"/>
                  </a:ext>
                </a:extLst>
              </a:tr>
              <a:tr h="381947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Prevalence of hypertension, n (%)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90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28.0)</a:t>
                      </a:r>
                      <a:endParaRPr kumimoji="1" lang="ja-JP" altLang="en-US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99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28.0)</a:t>
                      </a:r>
                      <a:endParaRPr kumimoji="1" lang="ja-JP" altLang="en-US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63341013"/>
                  </a:ext>
                </a:extLst>
              </a:tr>
              <a:tr h="3819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revalence of diabetes mellitus, n (%)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6.9)</a:t>
                      </a:r>
                      <a:endParaRPr kumimoji="1" lang="ja-JP" altLang="en-US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7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10.5)</a:t>
                      </a:r>
                      <a:endParaRPr kumimoji="1" lang="ja-JP" altLang="en-US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10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42206618"/>
                  </a:ext>
                </a:extLst>
              </a:tr>
              <a:tr h="3819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History of smoking, n (%)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0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18.7)</a:t>
                      </a:r>
                      <a:endParaRPr kumimoji="1" lang="ja-JP" altLang="en-US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1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17.3)</a:t>
                      </a:r>
                      <a:endParaRPr kumimoji="1" lang="ja-JP" altLang="en-US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69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35080928"/>
                  </a:ext>
                </a:extLst>
              </a:tr>
              <a:tr h="42928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revalence of constipa</a:t>
                      </a:r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tion n (%)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1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15.9)</a:t>
                      </a:r>
                      <a:endParaRPr kumimoji="1" lang="ja-JP" altLang="en-US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96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27.2)</a:t>
                      </a:r>
                      <a:endParaRPr kumimoji="1" lang="ja-JP" altLang="en-US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&lt;0.0001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73030048"/>
                  </a:ext>
                </a:extLst>
              </a:tr>
            </a:tbl>
          </a:graphicData>
        </a:graphic>
      </p:graphicFrame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2BB2F803-D7FB-8F13-9F8F-C3BD9041838F}"/>
              </a:ext>
            </a:extLst>
          </p:cNvPr>
          <p:cNvSpPr/>
          <p:nvPr/>
        </p:nvSpPr>
        <p:spPr>
          <a:xfrm>
            <a:off x="103957" y="48531"/>
            <a:ext cx="8582090" cy="73524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2800" dirty="0">
                <a:solidFill>
                  <a:schemeClr val="tx1"/>
                </a:solidFill>
              </a:rPr>
              <a:t>Supplemental Table1: Characteristics of the participants in </a:t>
            </a:r>
          </a:p>
          <a:p>
            <a:r>
              <a:rPr kumimoji="1" lang="en-US" altLang="ja-JP" sz="2800" dirty="0">
                <a:solidFill>
                  <a:schemeClr val="tx1"/>
                </a:solidFill>
              </a:rPr>
              <a:t>                                       the low IS and</a:t>
            </a:r>
            <a:r>
              <a:rPr kumimoji="1" lang="ja-JP" altLang="en-US" sz="2800" dirty="0">
                <a:solidFill>
                  <a:schemeClr val="tx1"/>
                </a:solidFill>
              </a:rPr>
              <a:t> </a:t>
            </a:r>
            <a:r>
              <a:rPr kumimoji="1" lang="en-US" altLang="ja-JP" sz="2800" dirty="0">
                <a:solidFill>
                  <a:schemeClr val="tx1"/>
                </a:solidFill>
              </a:rPr>
              <a:t>high IS groups.</a:t>
            </a:r>
            <a:r>
              <a:rPr kumimoji="1" lang="ja-JP" altLang="en-US" sz="2800" dirty="0">
                <a:solidFill>
                  <a:schemeClr val="tx1"/>
                </a:solidFill>
              </a:rPr>
              <a:t>  </a:t>
            </a:r>
            <a:endParaRPr kumimoji="1" lang="en-US" altLang="ja-JP" sz="2800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456967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>
        <a:ln w="38100"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  <a:txDef>
      <a:spPr>
        <a:noFill/>
      </a:spPr>
      <a:bodyPr wrap="none" rtlCol="0">
        <a:spAutoFit/>
      </a:bodyPr>
      <a:lstStyle>
        <a:defPPr algn="l">
          <a:defRPr kumimoji="1" dirty="0" smtClean="0">
            <a:latin typeface="Times New Roman" panose="02020603050405020304" pitchFamily="18" charset="0"/>
            <a:cs typeface="Times New Roman" panose="02020603050405020304" pitchFamily="18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811</TotalTime>
  <Words>251</Words>
  <Application>Microsoft Office PowerPoint</Application>
  <PresentationFormat>画面に合わせる (4:3)</PresentationFormat>
  <Paragraphs>84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貴弥 阿部</dc:creator>
  <cp:lastModifiedBy>瑞貴 久野</cp:lastModifiedBy>
  <cp:revision>8</cp:revision>
  <cp:lastPrinted>2024-02-04T05:40:39Z</cp:lastPrinted>
  <dcterms:created xsi:type="dcterms:W3CDTF">2024-01-17T10:41:08Z</dcterms:created>
  <dcterms:modified xsi:type="dcterms:W3CDTF">2025-12-03T11:56:42Z</dcterms:modified>
</cp:coreProperties>
</file>